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62B06-33A9-4297-8C8B-51066E1414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D332A-1C1C-48AE-9302-0896F00AD4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B87F7-2036-4987-ABB0-A034C9973D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FD8AD-EC15-4FEB-AD51-DE48770BC0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035B5-BFDF-4957-9DD4-76A475E0E5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316FB-78B3-44FA-9E8A-39A1C9FB70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C73D3-E72E-4AB3-AFFA-78C16A5A67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A3817-C73A-4B93-952A-FEF95879B0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1C898-37E1-4C46-A654-37B271A89B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B37D4-8882-4098-BEA0-D09F3B4221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0625E-0902-468A-8151-58148EF6AB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43B56-F5DF-41BE-8664-9C05CCAD6F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E44909-ACA4-491A-951B-39B983BC9C50}" type="slidenum">
              <a:rPr b="0" sz="12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2"/>
          <p:cNvGrpSpPr/>
          <p:nvPr/>
        </p:nvGrpSpPr>
        <p:grpSpPr>
          <a:xfrm>
            <a:off x="711360" y="938160"/>
            <a:ext cx="5435280" cy="7267680"/>
            <a:chOff x="711360" y="938160"/>
            <a:chExt cx="5435280" cy="7267680"/>
          </a:xfrm>
        </p:grpSpPr>
        <p:sp>
          <p:nvSpPr>
            <p:cNvPr id="42" name="矩形 1"/>
            <p:cNvSpPr/>
            <p:nvPr/>
          </p:nvSpPr>
          <p:spPr>
            <a:xfrm>
              <a:off x="711360" y="938160"/>
              <a:ext cx="5435280" cy="72676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组合 3"/>
            <p:cNvGrpSpPr/>
            <p:nvPr/>
          </p:nvGrpSpPr>
          <p:grpSpPr>
            <a:xfrm>
              <a:off x="711360" y="938160"/>
              <a:ext cx="5435280" cy="7267680"/>
              <a:chOff x="711360" y="938160"/>
              <a:chExt cx="5435280" cy="7267680"/>
            </a:xfrm>
          </p:grpSpPr>
          <p:grpSp>
            <p:nvGrpSpPr>
              <p:cNvPr id="44" name="组合 4"/>
              <p:cNvGrpSpPr/>
              <p:nvPr/>
            </p:nvGrpSpPr>
            <p:grpSpPr>
              <a:xfrm>
                <a:off x="2252520" y="938160"/>
                <a:ext cx="3894120" cy="7267680"/>
                <a:chOff x="2252520" y="938160"/>
                <a:chExt cx="3894120" cy="7267680"/>
              </a:xfrm>
            </p:grpSpPr>
            <p:pic>
              <p:nvPicPr>
                <p:cNvPr id="45" name="图片 19" descr="F:\文章\数据\motif图&amp;序列\motif1.png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252520" y="938160"/>
                  <a:ext cx="2875680" cy="1259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6" name="图片 20" descr="F:\文章\数据\motif图&amp;序列\motif2.png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2252520" y="2097360"/>
                  <a:ext cx="3894120" cy="1259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图片 21" descr="F:\文章\数据\motif图&amp;序列\motif_3.pn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252520" y="3263400"/>
                  <a:ext cx="1353240" cy="1258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8" name="图片 22" descr="F:\文章\数据\motif图&amp;序列\motif4.pn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2252520" y="4537800"/>
                  <a:ext cx="1533240" cy="12607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9" name="图片 23" descr="F:\文章\数据\motif图&amp;序列\motif_5.png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2252520" y="5812200"/>
                  <a:ext cx="1691640" cy="1260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0" name="图片 24" descr="F:\文章\数据\motif图&amp;序列\motif_6.png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2252520" y="6946200"/>
                  <a:ext cx="3390480" cy="12596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51" name="组合 5"/>
              <p:cNvGrpSpPr/>
              <p:nvPr/>
            </p:nvGrpSpPr>
            <p:grpSpPr>
              <a:xfrm>
                <a:off x="711360" y="1480320"/>
                <a:ext cx="676080" cy="6263640"/>
                <a:chOff x="711360" y="1480320"/>
                <a:chExt cx="676080" cy="6263640"/>
              </a:xfrm>
            </p:grpSpPr>
            <p:sp>
              <p:nvSpPr>
                <p:cNvPr id="52" name="文本框 2"/>
                <p:cNvSpPr/>
                <p:nvPr/>
              </p:nvSpPr>
              <p:spPr>
                <a:xfrm>
                  <a:off x="711360" y="1480320"/>
                  <a:ext cx="600120" cy="2476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Motif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文本框 2"/>
                <p:cNvSpPr/>
                <p:nvPr/>
              </p:nvSpPr>
              <p:spPr>
                <a:xfrm>
                  <a:off x="711360" y="2607480"/>
                  <a:ext cx="63828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Motif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文本框 16"/>
                <p:cNvSpPr/>
                <p:nvPr/>
              </p:nvSpPr>
              <p:spPr>
                <a:xfrm>
                  <a:off x="711360" y="3755520"/>
                  <a:ext cx="581040" cy="266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Motif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文本框 17"/>
                <p:cNvSpPr/>
                <p:nvPr/>
              </p:nvSpPr>
              <p:spPr>
                <a:xfrm>
                  <a:off x="711360" y="5052600"/>
                  <a:ext cx="581040" cy="3427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Motif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文本框 18"/>
                <p:cNvSpPr/>
                <p:nvPr/>
              </p:nvSpPr>
              <p:spPr>
                <a:xfrm>
                  <a:off x="711360" y="6318360"/>
                  <a:ext cx="676080" cy="3506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Motif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文本框 19"/>
                <p:cNvSpPr/>
                <p:nvPr/>
              </p:nvSpPr>
              <p:spPr>
                <a:xfrm>
                  <a:off x="711360" y="7486920"/>
                  <a:ext cx="581040" cy="257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Motif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8" name="组合 6"/>
              <p:cNvGrpSpPr/>
              <p:nvPr/>
            </p:nvGrpSpPr>
            <p:grpSpPr>
              <a:xfrm>
                <a:off x="1338480" y="1310040"/>
                <a:ext cx="1020240" cy="6606000"/>
                <a:chOff x="1338480" y="1310040"/>
                <a:chExt cx="1020240" cy="6606000"/>
              </a:xfrm>
            </p:grpSpPr>
            <p:sp>
              <p:nvSpPr>
                <p:cNvPr id="59" name="文本框 2"/>
                <p:cNvSpPr/>
                <p:nvPr/>
              </p:nvSpPr>
              <p:spPr>
                <a:xfrm>
                  <a:off x="1338480" y="1310040"/>
                  <a:ext cx="882360" cy="824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.60e-3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2 sit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5 a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文本框 2"/>
                <p:cNvSpPr/>
                <p:nvPr/>
              </p:nvSpPr>
              <p:spPr>
                <a:xfrm>
                  <a:off x="1338480" y="2405160"/>
                  <a:ext cx="882360" cy="824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.10e-3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2 sit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21 a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文本框 2"/>
                <p:cNvSpPr/>
                <p:nvPr/>
              </p:nvSpPr>
              <p:spPr>
                <a:xfrm>
                  <a:off x="1338480" y="3553200"/>
                  <a:ext cx="861840" cy="824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2.30e-0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0 sit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6 a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文本框 2"/>
                <p:cNvSpPr/>
                <p:nvPr/>
              </p:nvSpPr>
              <p:spPr>
                <a:xfrm>
                  <a:off x="1338480" y="4893120"/>
                  <a:ext cx="1020240" cy="6415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4.40e-0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1 sit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7 a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文本框 2"/>
                <p:cNvSpPr/>
                <p:nvPr/>
              </p:nvSpPr>
              <p:spPr>
                <a:xfrm>
                  <a:off x="1338480" y="6126840"/>
                  <a:ext cx="893520" cy="824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9.30e-0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3 sit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8 a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文本框 2"/>
                <p:cNvSpPr/>
                <p:nvPr/>
              </p:nvSpPr>
              <p:spPr>
                <a:xfrm>
                  <a:off x="1338480" y="7274520"/>
                  <a:ext cx="934560" cy="6415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5.80e-0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6 site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Wingdings 2"/>
                      <a:ea typeface="Wingdings 2"/>
                    </a:rPr>
                    <a:t>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宋体"/>
                    </a:rPr>
                    <a:t>18 a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65" name="矩形 4"/>
          <p:cNvSpPr/>
          <p:nvPr/>
        </p:nvSpPr>
        <p:spPr>
          <a:xfrm>
            <a:off x="260280" y="8543880"/>
            <a:ext cx="6193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6</a:t>
            </a:r>
            <a:r>
              <a:rPr b="1" lang="en-I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: 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Overview of conserved motifs of ZmSMR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rotein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 identifi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hrough MEME analysis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9T15:02:32Z</dcterms:created>
  <dc:creator>Anil</dc:creator>
  <dc:description/>
  <dc:language>en-US</dc:language>
  <cp:lastModifiedBy>Microsoft</cp:lastModifiedBy>
  <dcterms:modified xsi:type="dcterms:W3CDTF">2020-02-01T08:36:43Z</dcterms:modified>
  <cp:revision>15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00</vt:lpwstr>
  </property>
</Properties>
</file>